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6.xml.rels" ContentType="application/vnd.openxmlformats-package.relationships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7.wmf" ContentType="image/x-wmf"/>
  <Override PartName="/ppt/media/image13.png" ContentType="image/png"/>
  <Override PartName="/ppt/media/image1.png" ContentType="image/png"/>
  <Override PartName="/ppt/media/image5.png" ContentType="image/png"/>
  <Override PartName="/ppt/media/image14.wmf" ContentType="image/x-wmf"/>
  <Override PartName="/ppt/media/image6.png" ContentType="image/png"/>
  <Override PartName="/ppt/media/image10.wmf" ContentType="image/x-wmf"/>
  <Override PartName="/ppt/media/image2.png" ContentType="image/png"/>
  <Override PartName="/ppt/media/image15.wmf" ContentType="image/x-wmf"/>
  <Override PartName="/ppt/media/image7.png" ContentType="image/png"/>
  <Override PartName="/ppt/media/image11.wmf" ContentType="image/x-wmf"/>
  <Override PartName="/ppt/media/image3.png" ContentType="image/png"/>
  <Override PartName="/ppt/media/image16.wmf" ContentType="image/x-wmf"/>
  <Override PartName="/ppt/media/image8.png" ContentType="image/png"/>
  <Override PartName="/ppt/media/image12.wmf" ContentType="image/x-wmf"/>
  <Override PartName="/ppt/media/image4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A0F439-C8FF-450B-A978-080C119A328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_rels/notesSlide6.xml.rels><?xml version="1.0" encoding="UTF-8"?>
<Relationships xmlns="http://schemas.openxmlformats.org/package/2006/relationships"><Relationship Id="rId1" Type="http://schemas.openxmlformats.org/officeDocument/2006/relationships/slide" Target="../slides/slide6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23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Figure S1.  DC, monocyte subset signatures predict treatment non-response. 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a) 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ROC curves for the performance of signatures in predicting Infliximab response among 24 UC samples (GSE16879).  </a:t>
            </a:r>
            <a:r>
              <a:rPr b="1" lang="en-US" sz="1200" spc="-1" strike="noStrike">
                <a:solidFill>
                  <a:srgbClr val="000000"/>
                </a:solidFill>
                <a:latin typeface="Whitney-Book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 The area under the ROC curve (AUC) for signatures in predicting Infliximab response among 24 UC samples (GSE16879) in </a:t>
            </a:r>
            <a:r>
              <a:rPr b="1" lang="en-US" sz="1200" spc="-1" strike="noStrike">
                <a:solidFill>
                  <a:srgbClr val="000000"/>
                </a:solidFill>
                <a:latin typeface="Whitney-Bold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.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c) 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ROC curves for the performance of signatures in predicting Infliximab response among 19 CD samples (GSE16879).  </a:t>
            </a:r>
            <a:r>
              <a:rPr b="1" lang="en-US" sz="1200" spc="-1" strike="noStrike">
                <a:solidFill>
                  <a:srgbClr val="000000"/>
                </a:solidFill>
                <a:latin typeface="Whitney-Book"/>
              </a:rPr>
              <a:t>(d)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 AUC for signatures in predicting Infliximab response among 19 CD samples (GSE16879) in </a:t>
            </a:r>
            <a:r>
              <a:rPr b="1" lang="en-US" sz="1200" spc="-1" strike="noStrike">
                <a:solidFill>
                  <a:srgbClr val="000000"/>
                </a:solidFill>
                <a:latin typeface="Whitney-Bold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.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e) 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ROC curves for the performance of signatures in predicting Infliximab response among 23 UC samples (GSE73661).  </a:t>
            </a:r>
            <a:r>
              <a:rPr b="1" lang="en-US" sz="1200" spc="-1" strike="noStrike">
                <a:solidFill>
                  <a:srgbClr val="000000"/>
                </a:solidFill>
                <a:latin typeface="Whitney-Book"/>
              </a:rPr>
              <a:t>(f)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 AUC for signatures in predicting Infliximab response among 23 UC samples (GSE73661) in </a:t>
            </a:r>
            <a:r>
              <a:rPr b="1" lang="en-US" sz="1200" spc="-1" strike="noStrike">
                <a:solidFill>
                  <a:srgbClr val="000000"/>
                </a:solidFill>
                <a:latin typeface="Whitney-Bold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.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g) 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ROC curves for the performance of signatures in predicting Vedolizumab response among 41 UC samples (GSE73661).  </a:t>
            </a:r>
            <a:r>
              <a:rPr b="1" lang="en-US" sz="1200" spc="-1" strike="noStrike">
                <a:solidFill>
                  <a:srgbClr val="000000"/>
                </a:solidFill>
                <a:latin typeface="Whitney-Book"/>
              </a:rPr>
              <a:t>(h)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 AUC for signatures in predicting Vedolizumab response among 41 UC samples (GSE73661) in </a:t>
            </a:r>
            <a:r>
              <a:rPr b="1" lang="en-US" sz="1200" spc="-1" strike="noStrike">
                <a:solidFill>
                  <a:srgbClr val="000000"/>
                </a:solidFill>
                <a:latin typeface="Whitney-Bold"/>
              </a:rPr>
              <a:t>g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5697C7-00A2-4169-86C9-1D6DA5680EF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26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Figure S1.  DC, monocyte subset signatures predict treatment non-response. 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a) 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ROC curves for the performance of signatures in predicting Infliximab response among 24 UC samples (GSE16879).  </a:t>
            </a:r>
            <a:r>
              <a:rPr b="1" lang="en-US" sz="1200" spc="-1" strike="noStrike">
                <a:solidFill>
                  <a:srgbClr val="000000"/>
                </a:solidFill>
                <a:latin typeface="Whitney-Book"/>
              </a:rPr>
              <a:t>(b)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 The area under the ROC curve (AUC) for signatures in predicting Infliximab response among 24 UC samples (GSE16879) in </a:t>
            </a:r>
            <a:r>
              <a:rPr b="1" lang="en-US" sz="1200" spc="-1" strike="noStrike">
                <a:solidFill>
                  <a:srgbClr val="000000"/>
                </a:solidFill>
                <a:latin typeface="Whitney-Bold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.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c) 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ROC curves for the performance of signatures in predicting Infliximab response among 19 CD samples (GSE16879).  </a:t>
            </a:r>
            <a:r>
              <a:rPr b="1" lang="en-US" sz="1200" spc="-1" strike="noStrike">
                <a:solidFill>
                  <a:srgbClr val="000000"/>
                </a:solidFill>
                <a:latin typeface="Whitney-Book"/>
              </a:rPr>
              <a:t>(d)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 AUC for signatures in predicting Infliximab response among 19 CD samples (GSE16879) in </a:t>
            </a:r>
            <a:r>
              <a:rPr b="1" lang="en-US" sz="1200" spc="-1" strike="noStrike">
                <a:solidFill>
                  <a:srgbClr val="000000"/>
                </a:solidFill>
                <a:latin typeface="Whitney-Bold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.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e) 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ROC curves for the performance of signatures in predicting Infliximab response among 23 UC samples (GSE73661).  </a:t>
            </a:r>
            <a:r>
              <a:rPr b="1" lang="en-US" sz="1200" spc="-1" strike="noStrike">
                <a:solidFill>
                  <a:srgbClr val="000000"/>
                </a:solidFill>
                <a:latin typeface="Whitney-Book"/>
              </a:rPr>
              <a:t>(f)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 AUC for signatures in predicting Infliximab response among 23 UC samples (GSE73661) in </a:t>
            </a:r>
            <a:r>
              <a:rPr b="1" lang="en-US" sz="1200" spc="-1" strike="noStrike">
                <a:solidFill>
                  <a:srgbClr val="000000"/>
                </a:solidFill>
                <a:latin typeface="Whitney-Bold"/>
              </a:rPr>
              <a:t>e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.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g) 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ROC curves for the performance of signatures in predicting Vedolizumab response among 41 UC samples (GSE73661).  </a:t>
            </a:r>
            <a:r>
              <a:rPr b="1" lang="en-US" sz="1200" spc="-1" strike="noStrike">
                <a:solidFill>
                  <a:srgbClr val="000000"/>
                </a:solidFill>
                <a:latin typeface="Whitney-Book"/>
              </a:rPr>
              <a:t>(h)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 AUC for signatures in predicting Vedolizumab response among 41 UC samples (GSE73661) in </a:t>
            </a:r>
            <a:r>
              <a:rPr b="1" lang="en-US" sz="1200" spc="-1" strike="noStrike">
                <a:solidFill>
                  <a:srgbClr val="000000"/>
                </a:solidFill>
                <a:latin typeface="Whitney-Bold"/>
              </a:rPr>
              <a:t>g</a:t>
            </a:r>
            <a:r>
              <a:rPr b="0" lang="en-US" sz="1200" spc="-1" strike="noStrike">
                <a:solidFill>
                  <a:srgbClr val="000000"/>
                </a:solidFill>
                <a:latin typeface="Whitney-Book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C31DE7-6E5F-4487-BCAA-B28133A4DF4B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29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Figure S2.  Evaluation of chemokine expression in treatment response data sets. 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a) </a:t>
            </a: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Chemokines retain high expression in non-responders after treatment of Infliximab (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SE16879). 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b) </a:t>
            </a: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Median expression of chemokines involved in myeloid cell trafficking </a:t>
            </a:r>
            <a:r>
              <a:rPr b="0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in CD and UC patients in response to Infliximab (GSE16879).  </a:t>
            </a:r>
            <a:r>
              <a:rPr b="1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(c)</a:t>
            </a:r>
            <a:r>
              <a:rPr b="0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 </a:t>
            </a: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Median expression of chemokines involved in myeloid cell trafficking in </a:t>
            </a:r>
            <a:r>
              <a:rPr b="0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UC patients in response to either Infliximab or Vedolizumab (GSE73661).  IFX: Infliximab; VDZ: Vedolizumab.  NR: non-responder; R: responder. B/Before: Before treatment; A/After: After treatment.  W0: week 0 before treatment; W4_W6: week 4-6 after treatment of Infliximab; W52: week 52 after treatment of Vedolizumab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 P value &lt; 0.05, ** P value &lt; 0.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0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D528BD-A452-43D8-A0C8-DE4A44DC276D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32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Figure S2.  Evaluation of chemokine expression in treatment response data sets. 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a) </a:t>
            </a: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Chemokines retain high expression in non-responders after treatment of Infliximab (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SE16879).  </a:t>
            </a:r>
            <a:r>
              <a:rPr b="1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(b) </a:t>
            </a: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Median expression of chemokines involved in myeloid cell trafficking </a:t>
            </a:r>
            <a:r>
              <a:rPr b="0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in CD and UC patients in response to Infliximab (GSE16879).  </a:t>
            </a:r>
            <a:r>
              <a:rPr b="1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(c)</a:t>
            </a:r>
            <a:r>
              <a:rPr b="0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 </a:t>
            </a: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Median expression of chemokines involved in myeloid cell trafficking in </a:t>
            </a:r>
            <a:r>
              <a:rPr b="0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UC patients in response to either Infliximab or Vedolizumab (GSE73661).  IFX: Infliximab; VDZ: Vedolizumab.  NR: non-responder; R: responder. B/Before: Before treatment; A/After: After treatment.  W0: week 0 before treatment; W4_W6: week 4-6 after treatment of Infliximab; W52: week 52 after treatment of Vedolizumab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* P value &lt; 0.05, ** P value &lt; 0.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B7D3B8-D41B-43CE-AE9F-35771500E2F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35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Figure S3.  Expression of myeloid cell related chemokines in the stromal cells from UC patients and healthy controls (HC)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6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476E86-6733-4FF0-A7A9-6FF75098103A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6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138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333333"/>
                </a:solidFill>
                <a:latin typeface="Noto Serif"/>
                <a:ea typeface="Times New Roman"/>
              </a:rPr>
              <a:t>Figure S4.  Expressions of IL17A and IL22 </a:t>
            </a:r>
            <a:r>
              <a:rPr b="0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in response to biological treatment in IBD patients.  </a:t>
            </a:r>
            <a:r>
              <a:rPr b="1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(a) </a:t>
            </a:r>
            <a:r>
              <a:rPr b="0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CD and UC patients (GSE16879). </a:t>
            </a:r>
            <a:r>
              <a:rPr b="1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(b)</a:t>
            </a:r>
            <a:r>
              <a:rPr b="0" lang="en-US" sz="1200" spc="-1" strike="noStrike">
                <a:solidFill>
                  <a:srgbClr val="666666"/>
                </a:solidFill>
                <a:latin typeface="Noto Serif"/>
                <a:ea typeface="Calibri"/>
              </a:rPr>
              <a:t> UC patients (GSE73661). IFX: Infliximab; VDZ: Vedolizumab.  NR: non-responder; R: responder. Before: before treatment of Infliximab; After: after treatment of Infliximab.  W0: week 0 before treatment; W4_W6: week 4-6 after treatment of Infliximab; W52: week 52 after treatment of Vedolizumab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10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9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F9E7D8-89E3-48B4-8B62-BC550A2C21B9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C100D-350B-4C18-9218-FD1D95F9600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573536-8955-4F2F-A514-D3F57B3556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B8BD8-36AE-402E-9BED-EAF466173B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10CE11-D0C7-4B63-A3FF-F3DCC26E21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C4C81-76F0-4BBB-BC26-B6EBDA36AB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53B560-9CA8-424B-8602-93BA913546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730FE-BDD7-474B-AC9B-969FB66224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47E7AB-B50A-4024-A435-34F546FBBF5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3C0A3-F52B-4C85-AAF8-3CF885590C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4B0F84-44BA-4B21-99B6-ECE01A2FF3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AFB9B-EA31-4456-83D7-E256C84B3B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1FBEE2-A1A7-412E-8C7A-4AF175C794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1E564FB-5692-429E-8A65-1C32F20C8C48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9.png"/><Relationship Id="rId3" Type="http://schemas.openxmlformats.org/officeDocument/2006/relationships/image" Target="../media/image10.wmf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wmf"/><Relationship Id="rId2" Type="http://schemas.openxmlformats.org/officeDocument/2006/relationships/image" Target="../media/image12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4.wmf"/><Relationship Id="rId2" Type="http://schemas.openxmlformats.org/officeDocument/2006/relationships/image" Target="../media/image15.wmf"/><Relationship Id="rId3" Type="http://schemas.openxmlformats.org/officeDocument/2006/relationships/image" Target="../media/image16.wmf"/><Relationship Id="rId4" Type="http://schemas.openxmlformats.org/officeDocument/2006/relationships/image" Target="../media/image17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6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6" descr=""/>
          <p:cNvPicPr/>
          <p:nvPr/>
        </p:nvPicPr>
        <p:blipFill>
          <a:blip r:embed="rId1"/>
          <a:srcRect l="0" t="0" r="13392" b="0"/>
          <a:stretch/>
        </p:blipFill>
        <p:spPr>
          <a:xfrm>
            <a:off x="4411800" y="3462480"/>
            <a:ext cx="3859200" cy="30067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2" descr=""/>
          <p:cNvPicPr/>
          <p:nvPr/>
        </p:nvPicPr>
        <p:blipFill>
          <a:blip r:embed="rId2"/>
          <a:srcRect l="0" t="0" r="15446" b="4095"/>
          <a:stretch/>
        </p:blipFill>
        <p:spPr>
          <a:xfrm>
            <a:off x="264960" y="3309840"/>
            <a:ext cx="4238640" cy="324324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" descr=""/>
          <p:cNvPicPr/>
          <p:nvPr/>
        </p:nvPicPr>
        <p:blipFill>
          <a:blip r:embed="rId3"/>
          <a:srcRect l="0" t="4828" r="13831" b="3076"/>
          <a:stretch/>
        </p:blipFill>
        <p:spPr>
          <a:xfrm>
            <a:off x="233280" y="380880"/>
            <a:ext cx="4399200" cy="31705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7" descr=""/>
          <p:cNvPicPr/>
          <p:nvPr/>
        </p:nvPicPr>
        <p:blipFill>
          <a:blip r:embed="rId4"/>
          <a:srcRect l="8080" t="0" r="0" b="3922"/>
          <a:stretch/>
        </p:blipFill>
        <p:spPr>
          <a:xfrm>
            <a:off x="4764240" y="388800"/>
            <a:ext cx="4278240" cy="3016440"/>
          </a:xfrm>
          <a:prstGeom prst="rect">
            <a:avLst/>
          </a:prstGeom>
          <a:ln w="0">
            <a:noFill/>
          </a:ln>
        </p:spPr>
      </p:pic>
      <p:sp>
        <p:nvSpPr>
          <p:cNvPr id="52" name="TextBox 37"/>
          <p:cNvSpPr/>
          <p:nvPr/>
        </p:nvSpPr>
        <p:spPr>
          <a:xfrm>
            <a:off x="231120" y="457200"/>
            <a:ext cx="331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37"/>
          <p:cNvSpPr/>
          <p:nvPr/>
        </p:nvSpPr>
        <p:spPr>
          <a:xfrm>
            <a:off x="248040" y="3500280"/>
            <a:ext cx="308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37"/>
          <p:cNvSpPr/>
          <p:nvPr/>
        </p:nvSpPr>
        <p:spPr>
          <a:xfrm>
            <a:off x="4588920" y="457200"/>
            <a:ext cx="34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37"/>
          <p:cNvSpPr/>
          <p:nvPr/>
        </p:nvSpPr>
        <p:spPr>
          <a:xfrm>
            <a:off x="4606200" y="3500280"/>
            <a:ext cx="34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38"/>
          <p:cNvSpPr/>
          <p:nvPr/>
        </p:nvSpPr>
        <p:spPr>
          <a:xfrm>
            <a:off x="69120" y="76320"/>
            <a:ext cx="78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g.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" name="Picture 7" descr=""/>
          <p:cNvPicPr/>
          <p:nvPr/>
        </p:nvPicPr>
        <p:blipFill>
          <a:blip r:embed="rId5"/>
          <a:srcRect l="83482" t="15249" r="1340" b="32454"/>
          <a:stretch/>
        </p:blipFill>
        <p:spPr>
          <a:xfrm>
            <a:off x="8396280" y="3886200"/>
            <a:ext cx="706320" cy="16416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7" descr=""/>
          <p:cNvPicPr/>
          <p:nvPr/>
        </p:nvPicPr>
        <p:blipFill>
          <a:blip r:embed="rId1"/>
          <a:stretch/>
        </p:blipFill>
        <p:spPr>
          <a:xfrm>
            <a:off x="4289400" y="3467160"/>
            <a:ext cx="4613400" cy="311292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" descr=""/>
          <p:cNvPicPr/>
          <p:nvPr/>
        </p:nvPicPr>
        <p:blipFill>
          <a:blip r:embed="rId2"/>
          <a:srcRect l="2961" t="7314" r="14175" b="4217"/>
          <a:stretch/>
        </p:blipFill>
        <p:spPr>
          <a:xfrm>
            <a:off x="299880" y="609480"/>
            <a:ext cx="4091040" cy="294660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3" descr=""/>
          <p:cNvPicPr/>
          <p:nvPr/>
        </p:nvPicPr>
        <p:blipFill>
          <a:blip r:embed="rId3"/>
          <a:srcRect l="2082" t="8302" r="15006" b="3178"/>
          <a:stretch/>
        </p:blipFill>
        <p:spPr>
          <a:xfrm>
            <a:off x="162000" y="3549600"/>
            <a:ext cx="4276800" cy="307980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4" descr=""/>
          <p:cNvPicPr/>
          <p:nvPr/>
        </p:nvPicPr>
        <p:blipFill>
          <a:blip r:embed="rId4"/>
          <a:srcRect l="7269" t="3830" r="0" b="3300"/>
          <a:stretch/>
        </p:blipFill>
        <p:spPr>
          <a:xfrm>
            <a:off x="4619520" y="641520"/>
            <a:ext cx="4272120" cy="2885760"/>
          </a:xfrm>
          <a:prstGeom prst="rect">
            <a:avLst/>
          </a:prstGeom>
          <a:ln w="0">
            <a:noFill/>
          </a:ln>
        </p:spPr>
      </p:pic>
      <p:sp>
        <p:nvSpPr>
          <p:cNvPr id="62" name="TextBox 38"/>
          <p:cNvSpPr/>
          <p:nvPr/>
        </p:nvSpPr>
        <p:spPr>
          <a:xfrm>
            <a:off x="73080" y="76320"/>
            <a:ext cx="78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g.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37"/>
          <p:cNvSpPr/>
          <p:nvPr/>
        </p:nvSpPr>
        <p:spPr>
          <a:xfrm>
            <a:off x="231120" y="457200"/>
            <a:ext cx="334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e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7"/>
          <p:cNvSpPr/>
          <p:nvPr/>
        </p:nvSpPr>
        <p:spPr>
          <a:xfrm>
            <a:off x="248400" y="3500280"/>
            <a:ext cx="3254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g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7"/>
          <p:cNvSpPr/>
          <p:nvPr/>
        </p:nvSpPr>
        <p:spPr>
          <a:xfrm>
            <a:off x="4589280" y="457200"/>
            <a:ext cx="2768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f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7"/>
          <p:cNvSpPr/>
          <p:nvPr/>
        </p:nvSpPr>
        <p:spPr>
          <a:xfrm>
            <a:off x="4606200" y="3500280"/>
            <a:ext cx="34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h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Picture 28" descr=""/>
          <p:cNvPicPr/>
          <p:nvPr/>
        </p:nvPicPr>
        <p:blipFill>
          <a:blip r:embed="rId1"/>
          <a:srcRect l="32397" t="94373" r="3739" b="76"/>
          <a:stretch/>
        </p:blipFill>
        <p:spPr>
          <a:xfrm>
            <a:off x="2432160" y="1111320"/>
            <a:ext cx="4327560" cy="101916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2" descr=""/>
          <p:cNvPicPr/>
          <p:nvPr/>
        </p:nvPicPr>
        <p:blipFill>
          <a:blip r:embed="rId2"/>
          <a:srcRect l="31770" t="0" r="3633" b="6363"/>
          <a:stretch/>
        </p:blipFill>
        <p:spPr>
          <a:xfrm>
            <a:off x="2430360" y="2049480"/>
            <a:ext cx="4259520" cy="350676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5" descr=""/>
          <p:cNvPicPr/>
          <p:nvPr/>
        </p:nvPicPr>
        <p:blipFill>
          <a:blip r:embed="rId3"/>
          <a:srcRect l="804" t="964" r="1552" b="2076"/>
          <a:stretch/>
        </p:blipFill>
        <p:spPr>
          <a:xfrm>
            <a:off x="6846840" y="3759120"/>
            <a:ext cx="1535040" cy="1773360"/>
          </a:xfrm>
          <a:prstGeom prst="rect">
            <a:avLst/>
          </a:prstGeom>
          <a:ln w="0">
            <a:noFill/>
          </a:ln>
        </p:spPr>
      </p:pic>
      <p:sp>
        <p:nvSpPr>
          <p:cNvPr id="70" name="TextBox 15"/>
          <p:cNvSpPr/>
          <p:nvPr/>
        </p:nvSpPr>
        <p:spPr>
          <a:xfrm>
            <a:off x="2389680" y="1314360"/>
            <a:ext cx="5022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co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16"/>
          <p:cNvSpPr/>
          <p:nvPr/>
        </p:nvSpPr>
        <p:spPr>
          <a:xfrm>
            <a:off x="3380400" y="1109520"/>
            <a:ext cx="2503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D                          U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17"/>
          <p:cNvSpPr/>
          <p:nvPr/>
        </p:nvSpPr>
        <p:spPr>
          <a:xfrm>
            <a:off x="2814120" y="1406520"/>
            <a:ext cx="3728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NR         R                 NR             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18"/>
          <p:cNvSpPr/>
          <p:nvPr/>
        </p:nvSpPr>
        <p:spPr>
          <a:xfrm>
            <a:off x="2752200" y="1687680"/>
            <a:ext cx="4024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   A    B      A        B          A      B    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19"/>
          <p:cNvSpPr/>
          <p:nvPr/>
        </p:nvSpPr>
        <p:spPr>
          <a:xfrm>
            <a:off x="3440160" y="2082960"/>
            <a:ext cx="1025640" cy="348912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20"/>
          <p:cNvSpPr/>
          <p:nvPr/>
        </p:nvSpPr>
        <p:spPr>
          <a:xfrm>
            <a:off x="2751120" y="2082960"/>
            <a:ext cx="673200" cy="348912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21"/>
          <p:cNvSpPr/>
          <p:nvPr/>
        </p:nvSpPr>
        <p:spPr>
          <a:xfrm>
            <a:off x="4479840" y="2084400"/>
            <a:ext cx="1474920" cy="34876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22"/>
          <p:cNvSpPr/>
          <p:nvPr/>
        </p:nvSpPr>
        <p:spPr>
          <a:xfrm>
            <a:off x="5973840" y="2082960"/>
            <a:ext cx="725400" cy="348912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23"/>
          <p:cNvSpPr/>
          <p:nvPr/>
        </p:nvSpPr>
        <p:spPr>
          <a:xfrm>
            <a:off x="2475000" y="2082960"/>
            <a:ext cx="299880" cy="348912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traight Connector 24"/>
          <p:cNvSpPr/>
          <p:nvPr/>
        </p:nvSpPr>
        <p:spPr>
          <a:xfrm>
            <a:off x="3956040" y="2093760"/>
            <a:ext cx="9360" cy="3467160"/>
          </a:xfrm>
          <a:prstGeom prst="line">
            <a:avLst/>
          </a:prstGeom>
          <a:ln w="284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Straight Connector 25"/>
          <p:cNvSpPr/>
          <p:nvPr/>
        </p:nvSpPr>
        <p:spPr>
          <a:xfrm>
            <a:off x="3105000" y="2093760"/>
            <a:ext cx="0" cy="3478320"/>
          </a:xfrm>
          <a:prstGeom prst="line">
            <a:avLst/>
          </a:prstGeom>
          <a:ln w="284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Straight Connector 26"/>
          <p:cNvSpPr/>
          <p:nvPr/>
        </p:nvSpPr>
        <p:spPr>
          <a:xfrm>
            <a:off x="5224320" y="2089080"/>
            <a:ext cx="17640" cy="3483000"/>
          </a:xfrm>
          <a:prstGeom prst="line">
            <a:avLst/>
          </a:prstGeom>
          <a:ln w="284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27"/>
          <p:cNvSpPr/>
          <p:nvPr/>
        </p:nvSpPr>
        <p:spPr>
          <a:xfrm>
            <a:off x="6337440" y="2077920"/>
            <a:ext cx="0" cy="3494160"/>
          </a:xfrm>
          <a:prstGeom prst="line">
            <a:avLst/>
          </a:prstGeom>
          <a:ln w="2844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38"/>
          <p:cNvSpPr/>
          <p:nvPr/>
        </p:nvSpPr>
        <p:spPr>
          <a:xfrm>
            <a:off x="69120" y="76320"/>
            <a:ext cx="78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g.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8"/>
          <p:cNvSpPr/>
          <p:nvPr/>
        </p:nvSpPr>
        <p:spPr>
          <a:xfrm>
            <a:off x="1606680" y="2081160"/>
            <a:ext cx="1143000" cy="374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CL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CL3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CL4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CL18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CL2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CL24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XCL1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XCL2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XCL3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XCL5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XCL6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XCL9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XCL10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XCL11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Arial"/>
              </a:rPr>
              <a:t>CXCL13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37"/>
          <p:cNvSpPr/>
          <p:nvPr/>
        </p:nvSpPr>
        <p:spPr>
          <a:xfrm>
            <a:off x="1647000" y="985680"/>
            <a:ext cx="331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1" descr=""/>
          <p:cNvPicPr/>
          <p:nvPr/>
        </p:nvPicPr>
        <p:blipFill>
          <a:blip r:embed="rId1"/>
          <a:srcRect l="0" t="0" r="0" b="2518"/>
          <a:stretch/>
        </p:blipFill>
        <p:spPr>
          <a:xfrm>
            <a:off x="4983120" y="2462040"/>
            <a:ext cx="3475080" cy="2689560"/>
          </a:xfrm>
          <a:prstGeom prst="rect">
            <a:avLst/>
          </a:prstGeom>
          <a:ln w="0">
            <a:noFill/>
          </a:ln>
        </p:spPr>
      </p:pic>
      <p:sp>
        <p:nvSpPr>
          <p:cNvPr id="87" name="TextBox 2"/>
          <p:cNvSpPr/>
          <p:nvPr/>
        </p:nvSpPr>
        <p:spPr>
          <a:xfrm>
            <a:off x="1361880" y="2023920"/>
            <a:ext cx="195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CD,UC) Inflixima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37"/>
          <p:cNvSpPr/>
          <p:nvPr/>
        </p:nvSpPr>
        <p:spPr>
          <a:xfrm>
            <a:off x="393120" y="1878120"/>
            <a:ext cx="34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37"/>
          <p:cNvSpPr/>
          <p:nvPr/>
        </p:nvSpPr>
        <p:spPr>
          <a:xfrm>
            <a:off x="4642200" y="1878120"/>
            <a:ext cx="3088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c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5"/>
          <p:cNvSpPr/>
          <p:nvPr/>
        </p:nvSpPr>
        <p:spPr>
          <a:xfrm>
            <a:off x="5092560" y="2023920"/>
            <a:ext cx="3330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UC) Infliximab and Vedolizuma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6"/>
          <p:cNvSpPr/>
          <p:nvPr/>
        </p:nvSpPr>
        <p:spPr>
          <a:xfrm>
            <a:off x="6510960" y="3246480"/>
            <a:ext cx="33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7"/>
          <p:cNvSpPr/>
          <p:nvPr/>
        </p:nvSpPr>
        <p:spPr>
          <a:xfrm>
            <a:off x="5823720" y="3238560"/>
            <a:ext cx="2552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8"/>
          <p:cNvSpPr/>
          <p:nvPr/>
        </p:nvSpPr>
        <p:spPr>
          <a:xfrm>
            <a:off x="7873200" y="3246480"/>
            <a:ext cx="33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9"/>
          <p:cNvSpPr/>
          <p:nvPr/>
        </p:nvSpPr>
        <p:spPr>
          <a:xfrm>
            <a:off x="7185960" y="3236760"/>
            <a:ext cx="2552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Picture 10" descr=""/>
          <p:cNvPicPr/>
          <p:nvPr/>
        </p:nvPicPr>
        <p:blipFill>
          <a:blip r:embed="rId2"/>
          <a:srcRect l="0" t="0" r="0" b="9896"/>
          <a:stretch/>
        </p:blipFill>
        <p:spPr>
          <a:xfrm>
            <a:off x="576360" y="2446200"/>
            <a:ext cx="3430440" cy="2735280"/>
          </a:xfrm>
          <a:prstGeom prst="rect">
            <a:avLst/>
          </a:prstGeom>
          <a:ln w="0">
            <a:noFill/>
          </a:ln>
        </p:spPr>
      </p:pic>
      <p:sp>
        <p:nvSpPr>
          <p:cNvPr id="96" name="TextBox 11"/>
          <p:cNvSpPr/>
          <p:nvPr/>
        </p:nvSpPr>
        <p:spPr>
          <a:xfrm>
            <a:off x="2089080" y="2930400"/>
            <a:ext cx="33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12"/>
          <p:cNvSpPr/>
          <p:nvPr/>
        </p:nvSpPr>
        <p:spPr>
          <a:xfrm>
            <a:off x="1424880" y="2921040"/>
            <a:ext cx="33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13"/>
          <p:cNvSpPr/>
          <p:nvPr/>
        </p:nvSpPr>
        <p:spPr>
          <a:xfrm>
            <a:off x="3452040" y="2928960"/>
            <a:ext cx="33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14"/>
          <p:cNvSpPr/>
          <p:nvPr/>
        </p:nvSpPr>
        <p:spPr>
          <a:xfrm>
            <a:off x="2756520" y="2919240"/>
            <a:ext cx="33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38"/>
          <p:cNvSpPr/>
          <p:nvPr/>
        </p:nvSpPr>
        <p:spPr>
          <a:xfrm>
            <a:off x="69120" y="76320"/>
            <a:ext cx="78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g.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Picture 1" descr=""/>
          <p:cNvPicPr/>
          <p:nvPr/>
        </p:nvPicPr>
        <p:blipFill>
          <a:blip r:embed="rId1"/>
          <a:stretch/>
        </p:blipFill>
        <p:spPr>
          <a:xfrm>
            <a:off x="0" y="297000"/>
            <a:ext cx="9144000" cy="6264000"/>
          </a:xfrm>
          <a:prstGeom prst="rect">
            <a:avLst/>
          </a:prstGeom>
          <a:ln w="0">
            <a:noFill/>
          </a:ln>
        </p:spPr>
      </p:pic>
      <p:sp>
        <p:nvSpPr>
          <p:cNvPr id="102" name="TextBox 38"/>
          <p:cNvSpPr/>
          <p:nvPr/>
        </p:nvSpPr>
        <p:spPr>
          <a:xfrm>
            <a:off x="69120" y="76320"/>
            <a:ext cx="78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g. S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Picture 3" descr=""/>
          <p:cNvPicPr/>
          <p:nvPr/>
        </p:nvPicPr>
        <p:blipFill>
          <a:blip r:embed="rId1"/>
          <a:srcRect l="0" t="2931" r="0" b="11583"/>
          <a:stretch/>
        </p:blipFill>
        <p:spPr>
          <a:xfrm>
            <a:off x="887400" y="3395520"/>
            <a:ext cx="2854440" cy="1868760"/>
          </a:xfrm>
          <a:prstGeom prst="rect">
            <a:avLst/>
          </a:prstGeom>
          <a:ln w="0">
            <a:noFill/>
          </a:ln>
        </p:spPr>
      </p:pic>
      <p:sp>
        <p:nvSpPr>
          <p:cNvPr id="104" name="TextBox 4"/>
          <p:cNvSpPr/>
          <p:nvPr/>
        </p:nvSpPr>
        <p:spPr>
          <a:xfrm>
            <a:off x="1361880" y="1447920"/>
            <a:ext cx="195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CD,UC) Inflixima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37"/>
          <p:cNvSpPr/>
          <p:nvPr/>
        </p:nvSpPr>
        <p:spPr>
          <a:xfrm>
            <a:off x="536040" y="1306440"/>
            <a:ext cx="3315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" name="Picture 6" descr=""/>
          <p:cNvPicPr/>
          <p:nvPr/>
        </p:nvPicPr>
        <p:blipFill>
          <a:blip r:embed="rId2"/>
          <a:srcRect l="0" t="0" r="2713" b="32475"/>
          <a:stretch/>
        </p:blipFill>
        <p:spPr>
          <a:xfrm>
            <a:off x="863640" y="1795320"/>
            <a:ext cx="2817720" cy="157644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7" descr=""/>
          <p:cNvPicPr/>
          <p:nvPr/>
        </p:nvPicPr>
        <p:blipFill>
          <a:blip r:embed="rId3"/>
          <a:stretch/>
        </p:blipFill>
        <p:spPr>
          <a:xfrm>
            <a:off x="5141880" y="3308400"/>
            <a:ext cx="2916360" cy="2044800"/>
          </a:xfrm>
          <a:prstGeom prst="rect">
            <a:avLst/>
          </a:prstGeom>
          <a:ln w="0">
            <a:noFill/>
          </a:ln>
        </p:spPr>
      </p:pic>
      <p:sp>
        <p:nvSpPr>
          <p:cNvPr id="108" name="TextBox 37"/>
          <p:cNvSpPr/>
          <p:nvPr/>
        </p:nvSpPr>
        <p:spPr>
          <a:xfrm>
            <a:off x="4726800" y="1306440"/>
            <a:ext cx="343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9" name="Picture 9" descr=""/>
          <p:cNvPicPr/>
          <p:nvPr/>
        </p:nvPicPr>
        <p:blipFill>
          <a:blip r:embed="rId4"/>
          <a:srcRect l="0" t="0" r="0" b="24996"/>
          <a:stretch/>
        </p:blipFill>
        <p:spPr>
          <a:xfrm>
            <a:off x="5132520" y="1778040"/>
            <a:ext cx="2944800" cy="1589040"/>
          </a:xfrm>
          <a:prstGeom prst="rect">
            <a:avLst/>
          </a:prstGeom>
          <a:ln w="0">
            <a:noFill/>
          </a:ln>
        </p:spPr>
      </p:pic>
      <p:sp>
        <p:nvSpPr>
          <p:cNvPr id="110" name="TextBox 10"/>
          <p:cNvSpPr/>
          <p:nvPr/>
        </p:nvSpPr>
        <p:spPr>
          <a:xfrm>
            <a:off x="5047920" y="1447920"/>
            <a:ext cx="3330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(UC) Infliximab and Vedolizuma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11"/>
          <p:cNvSpPr/>
          <p:nvPr/>
        </p:nvSpPr>
        <p:spPr>
          <a:xfrm>
            <a:off x="1524960" y="2155680"/>
            <a:ext cx="2552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16"/>
          <p:cNvSpPr/>
          <p:nvPr/>
        </p:nvSpPr>
        <p:spPr>
          <a:xfrm>
            <a:off x="2125080" y="2155680"/>
            <a:ext cx="2552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19"/>
          <p:cNvSpPr/>
          <p:nvPr/>
        </p:nvSpPr>
        <p:spPr>
          <a:xfrm>
            <a:off x="2051640" y="3686040"/>
            <a:ext cx="33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20"/>
          <p:cNvSpPr/>
          <p:nvPr/>
        </p:nvSpPr>
        <p:spPr>
          <a:xfrm>
            <a:off x="2660040" y="3686040"/>
            <a:ext cx="2552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21"/>
          <p:cNvSpPr/>
          <p:nvPr/>
        </p:nvSpPr>
        <p:spPr>
          <a:xfrm>
            <a:off x="3268800" y="2155680"/>
            <a:ext cx="2347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TextBox 22"/>
          <p:cNvSpPr/>
          <p:nvPr/>
        </p:nvSpPr>
        <p:spPr>
          <a:xfrm>
            <a:off x="3197880" y="3686040"/>
            <a:ext cx="33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23"/>
          <p:cNvSpPr/>
          <p:nvPr/>
        </p:nvSpPr>
        <p:spPr>
          <a:xfrm>
            <a:off x="5875560" y="3849840"/>
            <a:ext cx="2552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24"/>
          <p:cNvSpPr/>
          <p:nvPr/>
        </p:nvSpPr>
        <p:spPr>
          <a:xfrm>
            <a:off x="6377760" y="2428920"/>
            <a:ext cx="33012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25"/>
          <p:cNvSpPr/>
          <p:nvPr/>
        </p:nvSpPr>
        <p:spPr>
          <a:xfrm>
            <a:off x="6438240" y="3849840"/>
            <a:ext cx="2552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26"/>
          <p:cNvSpPr/>
          <p:nvPr/>
        </p:nvSpPr>
        <p:spPr>
          <a:xfrm>
            <a:off x="7552800" y="2428920"/>
            <a:ext cx="25524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ff0000"/>
                </a:solidFill>
                <a:latin typeface="Arial"/>
                <a:ea typeface="Arial"/>
              </a:rPr>
              <a:t>*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38"/>
          <p:cNvSpPr/>
          <p:nvPr/>
        </p:nvSpPr>
        <p:spPr>
          <a:xfrm>
            <a:off x="69120" y="76320"/>
            <a:ext cx="787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Fig. S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8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5-30T18:03:09Z</dcterms:created>
  <dc:creator>holiu</dc:creator>
  <dc:description/>
  <dc:language>en-US</dc:language>
  <cp:lastModifiedBy>Liu, Hong</cp:lastModifiedBy>
  <cp:lastPrinted>2019-03-06T21:35:49Z</cp:lastPrinted>
  <dcterms:modified xsi:type="dcterms:W3CDTF">2019-10-16T14:14:29Z</dcterms:modified>
  <cp:revision>352</cp:revision>
  <dc:subject/>
  <dc:title>Slide 1</dc:title>
</cp:coreProperties>
</file>